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EF1A4-722C-B332-B1D0-2405517BBD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B2EB37-68F7-C201-96E2-0AB9AE8CD3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08C84C-E329-011A-ECA1-4E37B2275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0693A5-5ECC-A057-63DC-2D5BECE0F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836B15-54EB-17D6-F477-BBEB11326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696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6F481-C3CE-69EC-E29F-83FA720AF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9E4ACD-B4BD-0834-E0FE-6D61C57CC7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C7BDF8-B9E7-FB58-37E6-6C3121526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5E62C8-B2F3-A346-340E-734D45133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C0641A-0138-72CC-BA30-B34A8B7F6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73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2C6AEA-4587-471E-0FBC-D05C6FDFEB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0769C2-9C4D-0CD2-4A6C-C181F2CCB2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BC997C-75D9-2C13-0B0C-8AAFDC203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93CDC1-C7A8-D5B5-90D9-61F115DDC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ED2D6C-82B6-E65B-4D2C-D4E78BEAA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474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229EB2-8912-A0C6-8168-F0155BC977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255F21-B4A0-2C94-C30D-A5135672C3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C637AC-8673-665F-0970-1FC8D13AA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A3E0D-35ED-CBF9-2AB0-45FFE06ED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87B5F7-D841-65BB-C731-C578BF412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377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D9D15-C460-F0DE-8579-71892B95D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EF087B-E627-234A-EEF3-71832A714F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EFBA23-1F16-5F8B-6FA2-F27554E55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C66E44-43AE-215E-98D2-F24211CFA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8F2520-62FE-6467-3F60-BD5A4E102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576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43B1B-6FDB-ED8E-865F-9D6DD7A96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4CC0AB-E2F0-69E1-F4A0-809DAC697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3B0B41-C4C6-1E51-68A6-BDA74247F2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AC6F44-9731-198F-CF19-A2F585957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522EFB-3012-DAFC-F4DB-E4058AA70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0B4AFA-EAF6-FACC-A908-950AEC536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567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947B6-773D-CA69-9BD0-A4A908437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32C5E5-49FB-99CB-B81A-798453B40C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1AC67E-A257-00F5-B026-2E52BA6020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879E9E-8ADB-3E89-1528-28594A1C16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9E4A08-6A0F-F9AA-27BF-283DECBCF7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FA0F14-B3C9-57A2-C207-DC0839CCB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5CC737-75A0-A708-B5F9-242783C31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D5D0C9-0900-22DA-6EC3-5D0298972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95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75AC88-CD95-502B-FC0E-E26772838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B27780-F6CC-2BEB-F2B4-3D0E745617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023DF0-AC95-4BBC-1052-C298C70B8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6F3836-283E-4FAF-A2E1-FC8077E74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789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4E4BD6-42F2-8EAE-393C-F1E06A2BC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966550-4971-B589-80A2-4737F8291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37A273-20F5-D1BA-AD30-493D29C51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6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0DFE3-3592-0CBA-54D0-E40A524EFE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F0F22B-5C80-5559-C175-A7342C7534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C98481-AC9E-7E6C-F9AB-7746C70BF5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CBFB39-6680-823C-B243-02037928E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A1E494-D36B-52CF-D54E-9948FF901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AE3CDF-B56C-6FF7-F0AE-621F1C1E0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313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1BE50-ED6A-E701-5EC9-20D7C55398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4C0050-F761-66E9-318C-1DEFE901CD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82263E-2D0D-6293-F9C9-7DC1CD73BF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A520C8-6981-6D4A-3330-CCAD41212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07D28F-01FE-4C78-5CEF-487C4090C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801579-D84F-41C6-7CE5-DCCA35E8E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414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B8ED96-8DB7-BCC2-39B9-9B2570CAC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208224-25DB-1318-BC28-7FBFDF2B97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9CDF76-524F-60DF-A646-D2F2D2F99B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2E545-6C6A-41BE-A562-2123D8914124}" type="datetimeFigureOut">
              <a:rPr lang="en-US" smtClean="0"/>
              <a:t>6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74E7E-837F-C5A4-9C96-B3CCB94D20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3FE9D4-CBEA-0F4D-3F0E-4F0CC29B1C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A29B3-5D8B-4A9C-8D22-9B2B07CBB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002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4F756585-69C4-EF75-FAD2-13CB7357EE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9482915"/>
              </p:ext>
            </p:extLst>
          </p:nvPr>
        </p:nvGraphicFramePr>
        <p:xfrm>
          <a:off x="1015571" y="2721259"/>
          <a:ext cx="4547103" cy="952500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372812">
                  <a:extLst>
                    <a:ext uri="{9D8B030D-6E8A-4147-A177-3AD203B41FA5}">
                      <a16:colId xmlns:a16="http://schemas.microsoft.com/office/drawing/2014/main" val="486342963"/>
                    </a:ext>
                  </a:extLst>
                </a:gridCol>
                <a:gridCol w="477501">
                  <a:extLst>
                    <a:ext uri="{9D8B030D-6E8A-4147-A177-3AD203B41FA5}">
                      <a16:colId xmlns:a16="http://schemas.microsoft.com/office/drawing/2014/main" val="4230799855"/>
                    </a:ext>
                  </a:extLst>
                </a:gridCol>
                <a:gridCol w="846478">
                  <a:extLst>
                    <a:ext uri="{9D8B030D-6E8A-4147-A177-3AD203B41FA5}">
                      <a16:colId xmlns:a16="http://schemas.microsoft.com/office/drawing/2014/main" val="341499580"/>
                    </a:ext>
                  </a:extLst>
                </a:gridCol>
                <a:gridCol w="569744">
                  <a:extLst>
                    <a:ext uri="{9D8B030D-6E8A-4147-A177-3AD203B41FA5}">
                      <a16:colId xmlns:a16="http://schemas.microsoft.com/office/drawing/2014/main" val="2540770499"/>
                    </a:ext>
                  </a:extLst>
                </a:gridCol>
                <a:gridCol w="526335">
                  <a:extLst>
                    <a:ext uri="{9D8B030D-6E8A-4147-A177-3AD203B41FA5}">
                      <a16:colId xmlns:a16="http://schemas.microsoft.com/office/drawing/2014/main" val="32013249"/>
                    </a:ext>
                  </a:extLst>
                </a:gridCol>
                <a:gridCol w="754233">
                  <a:extLst>
                    <a:ext uri="{9D8B030D-6E8A-4147-A177-3AD203B41FA5}">
                      <a16:colId xmlns:a16="http://schemas.microsoft.com/office/drawing/2014/main" val="30019258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Dunnett's multiple comparisons tes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Mean Diff.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95.00% CI of diff.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Significant?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Summary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Adjusted P Value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671044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SKBR-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0.294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-0.9080 to 0.3186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o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317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178168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DA_MB23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2.0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2.64 to -11.4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Ye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****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&lt;0.000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97555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CF-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3.88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4.499 to -3.27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Ye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****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&lt;0.000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75313865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57CC3EDA-DF78-0D4F-2EFF-0756526D9EE1}"/>
              </a:ext>
            </a:extLst>
          </p:cNvPr>
          <p:cNvSpPr txBox="1"/>
          <p:nvPr/>
        </p:nvSpPr>
        <p:spPr>
          <a:xfrm>
            <a:off x="1015571" y="2260646"/>
            <a:ext cx="971274" cy="5222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D1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AD20F194-30E2-2A3F-938E-6E71D24CF4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1444692"/>
              </p:ext>
            </p:extLst>
          </p:nvPr>
        </p:nvGraphicFramePr>
        <p:xfrm>
          <a:off x="957439" y="4187196"/>
          <a:ext cx="4627814" cy="952500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397180">
                  <a:extLst>
                    <a:ext uri="{9D8B030D-6E8A-4147-A177-3AD203B41FA5}">
                      <a16:colId xmlns:a16="http://schemas.microsoft.com/office/drawing/2014/main" val="3642923287"/>
                    </a:ext>
                  </a:extLst>
                </a:gridCol>
                <a:gridCol w="485976">
                  <a:extLst>
                    <a:ext uri="{9D8B030D-6E8A-4147-A177-3AD203B41FA5}">
                      <a16:colId xmlns:a16="http://schemas.microsoft.com/office/drawing/2014/main" val="3182823858"/>
                    </a:ext>
                  </a:extLst>
                </a:gridCol>
                <a:gridCol w="861502">
                  <a:extLst>
                    <a:ext uri="{9D8B030D-6E8A-4147-A177-3AD203B41FA5}">
                      <a16:colId xmlns:a16="http://schemas.microsoft.com/office/drawing/2014/main" val="1965328570"/>
                    </a:ext>
                  </a:extLst>
                </a:gridCol>
                <a:gridCol w="579857">
                  <a:extLst>
                    <a:ext uri="{9D8B030D-6E8A-4147-A177-3AD203B41FA5}">
                      <a16:colId xmlns:a16="http://schemas.microsoft.com/office/drawing/2014/main" val="1816134055"/>
                    </a:ext>
                  </a:extLst>
                </a:gridCol>
                <a:gridCol w="535678">
                  <a:extLst>
                    <a:ext uri="{9D8B030D-6E8A-4147-A177-3AD203B41FA5}">
                      <a16:colId xmlns:a16="http://schemas.microsoft.com/office/drawing/2014/main" val="2222380822"/>
                    </a:ext>
                  </a:extLst>
                </a:gridCol>
                <a:gridCol w="767621">
                  <a:extLst>
                    <a:ext uri="{9D8B030D-6E8A-4147-A177-3AD203B41FA5}">
                      <a16:colId xmlns:a16="http://schemas.microsoft.com/office/drawing/2014/main" val="160552756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Dunnett's multiple comparisons tes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Mean Diff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95.00% CI of diff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Significant?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Summary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Adjusted P Valu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981473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SKBR-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0.381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.287 to 0.522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o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396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947089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DA_MB23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2.31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3.222 to -1.4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Ye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**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001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96107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CF-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2.73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3.639 to -1.83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Ye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***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0.0009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70652481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96CD2BFF-1540-6CD5-2267-56DD28E0B0F6}"/>
              </a:ext>
            </a:extLst>
          </p:cNvPr>
          <p:cNvSpPr txBox="1"/>
          <p:nvPr/>
        </p:nvSpPr>
        <p:spPr>
          <a:xfrm>
            <a:off x="1015571" y="3787330"/>
            <a:ext cx="971274" cy="5222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D2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9C7146B2-C6BB-3857-865C-C4615D51D3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8646231"/>
              </p:ext>
            </p:extLst>
          </p:nvPr>
        </p:nvGraphicFramePr>
        <p:xfrm>
          <a:off x="6231038" y="2687392"/>
          <a:ext cx="4739016" cy="952500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430753">
                  <a:extLst>
                    <a:ext uri="{9D8B030D-6E8A-4147-A177-3AD203B41FA5}">
                      <a16:colId xmlns:a16="http://schemas.microsoft.com/office/drawing/2014/main" val="2399221072"/>
                    </a:ext>
                  </a:extLst>
                </a:gridCol>
                <a:gridCol w="497653">
                  <a:extLst>
                    <a:ext uri="{9D8B030D-6E8A-4147-A177-3AD203B41FA5}">
                      <a16:colId xmlns:a16="http://schemas.microsoft.com/office/drawing/2014/main" val="193006702"/>
                    </a:ext>
                  </a:extLst>
                </a:gridCol>
                <a:gridCol w="882203">
                  <a:extLst>
                    <a:ext uri="{9D8B030D-6E8A-4147-A177-3AD203B41FA5}">
                      <a16:colId xmlns:a16="http://schemas.microsoft.com/office/drawing/2014/main" val="1764232220"/>
                    </a:ext>
                  </a:extLst>
                </a:gridCol>
                <a:gridCol w="593791">
                  <a:extLst>
                    <a:ext uri="{9D8B030D-6E8A-4147-A177-3AD203B41FA5}">
                      <a16:colId xmlns:a16="http://schemas.microsoft.com/office/drawing/2014/main" val="2753090288"/>
                    </a:ext>
                  </a:extLst>
                </a:gridCol>
                <a:gridCol w="548550">
                  <a:extLst>
                    <a:ext uri="{9D8B030D-6E8A-4147-A177-3AD203B41FA5}">
                      <a16:colId xmlns:a16="http://schemas.microsoft.com/office/drawing/2014/main" val="4088712785"/>
                    </a:ext>
                  </a:extLst>
                </a:gridCol>
                <a:gridCol w="786066">
                  <a:extLst>
                    <a:ext uri="{9D8B030D-6E8A-4147-A177-3AD203B41FA5}">
                      <a16:colId xmlns:a16="http://schemas.microsoft.com/office/drawing/2014/main" val="1253933514"/>
                    </a:ext>
                  </a:extLst>
                </a:gridCol>
              </a:tblGrid>
              <a:tr h="37419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Dunnett's multiple comparisons tes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Mean Diff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95.00% CI of diff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Significant?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Summary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Adjusted P Valu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2488870"/>
                  </a:ext>
                </a:extLst>
              </a:tr>
              <a:tr h="19276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SKBR-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468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.964 to 2.90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o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829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31050789"/>
                  </a:ext>
                </a:extLst>
              </a:tr>
              <a:tr h="19276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DA_MB23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0.130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2.562 to 2.30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o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994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58299896"/>
                  </a:ext>
                </a:extLst>
              </a:tr>
              <a:tr h="19276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CF-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9.17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1.61 to -6.74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Ye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***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0.0004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37499538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0C1DF654-206A-7D1E-4080-205C05D12EE6}"/>
              </a:ext>
            </a:extLst>
          </p:cNvPr>
          <p:cNvSpPr txBox="1"/>
          <p:nvPr/>
        </p:nvSpPr>
        <p:spPr>
          <a:xfrm>
            <a:off x="6177344" y="2235246"/>
            <a:ext cx="971274" cy="5222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D3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6F647722-A3F2-552E-90AB-00A307D948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9391746"/>
              </p:ext>
            </p:extLst>
          </p:nvPr>
        </p:nvGraphicFramePr>
        <p:xfrm>
          <a:off x="6231038" y="4110996"/>
          <a:ext cx="4792710" cy="1028699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446964">
                  <a:extLst>
                    <a:ext uri="{9D8B030D-6E8A-4147-A177-3AD203B41FA5}">
                      <a16:colId xmlns:a16="http://schemas.microsoft.com/office/drawing/2014/main" val="497142457"/>
                    </a:ext>
                  </a:extLst>
                </a:gridCol>
                <a:gridCol w="503292">
                  <a:extLst>
                    <a:ext uri="{9D8B030D-6E8A-4147-A177-3AD203B41FA5}">
                      <a16:colId xmlns:a16="http://schemas.microsoft.com/office/drawing/2014/main" val="1320746463"/>
                    </a:ext>
                  </a:extLst>
                </a:gridCol>
                <a:gridCol w="892199">
                  <a:extLst>
                    <a:ext uri="{9D8B030D-6E8A-4147-A177-3AD203B41FA5}">
                      <a16:colId xmlns:a16="http://schemas.microsoft.com/office/drawing/2014/main" val="1731024276"/>
                    </a:ext>
                  </a:extLst>
                </a:gridCol>
                <a:gridCol w="600518">
                  <a:extLst>
                    <a:ext uri="{9D8B030D-6E8A-4147-A177-3AD203B41FA5}">
                      <a16:colId xmlns:a16="http://schemas.microsoft.com/office/drawing/2014/main" val="2790589427"/>
                    </a:ext>
                  </a:extLst>
                </a:gridCol>
                <a:gridCol w="554765">
                  <a:extLst>
                    <a:ext uri="{9D8B030D-6E8A-4147-A177-3AD203B41FA5}">
                      <a16:colId xmlns:a16="http://schemas.microsoft.com/office/drawing/2014/main" val="3342427500"/>
                    </a:ext>
                  </a:extLst>
                </a:gridCol>
                <a:gridCol w="794972">
                  <a:extLst>
                    <a:ext uri="{9D8B030D-6E8A-4147-A177-3AD203B41FA5}">
                      <a16:colId xmlns:a16="http://schemas.microsoft.com/office/drawing/2014/main" val="4207829980"/>
                    </a:ext>
                  </a:extLst>
                </a:gridCol>
              </a:tblGrid>
              <a:tr h="40413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Dunnett's multiple comparisons test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Mean Diff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95.00% CI of diff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Significant?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Summary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Adjusted P Valu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77194177"/>
                  </a:ext>
                </a:extLst>
              </a:tr>
              <a:tr h="20818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SKBR-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0661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.879 to 2.01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o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998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9912762"/>
                  </a:ext>
                </a:extLst>
              </a:tr>
              <a:tr h="20818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Fibro vs. MDA_MB23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1.68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3.634 to 0.256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o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0.076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1032682"/>
                  </a:ext>
                </a:extLst>
              </a:tr>
              <a:tr h="20818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Fibro vs. MCF-7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7.33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-9.275 to -5.38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Ye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>
                          <a:effectLst/>
                        </a:rPr>
                        <a:t>***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000" b="0" u="none" strike="noStrike" dirty="0">
                          <a:effectLst/>
                        </a:rPr>
                        <a:t>0.0004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244159"/>
                  </a:ext>
                </a:extLst>
              </a:tr>
            </a:tbl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9F478F82-8096-485A-B2A4-9121E9EA3910}"/>
              </a:ext>
            </a:extLst>
          </p:cNvPr>
          <p:cNvSpPr txBox="1"/>
          <p:nvPr/>
        </p:nvSpPr>
        <p:spPr>
          <a:xfrm>
            <a:off x="6191384" y="3682226"/>
            <a:ext cx="971274" cy="5222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SR</a:t>
            </a:r>
            <a:endParaRPr lang="en-US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B5755BD-1D1D-14FF-B859-CB9578D92C31}"/>
              </a:ext>
            </a:extLst>
          </p:cNvPr>
          <p:cNvSpPr txBox="1"/>
          <p:nvPr/>
        </p:nvSpPr>
        <p:spPr>
          <a:xfrm>
            <a:off x="1015570" y="1000460"/>
            <a:ext cx="4369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-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detail statistical analysis. </a:t>
            </a:r>
          </a:p>
        </p:txBody>
      </p:sp>
    </p:spTree>
    <p:extLst>
      <p:ext uri="{BB962C8B-B14F-4D97-AF65-F5344CB8AC3E}">
        <p14:creationId xmlns:p14="http://schemas.microsoft.com/office/powerpoint/2010/main" val="3043517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57</Words>
  <Application>Microsoft Office PowerPoint</Application>
  <PresentationFormat>Widescreen</PresentationFormat>
  <Paragraphs>10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hammad amin Javidi</dc:creator>
  <cp:lastModifiedBy>Mohammad amin Javidi</cp:lastModifiedBy>
  <cp:revision>2</cp:revision>
  <dcterms:created xsi:type="dcterms:W3CDTF">2026-06-15T10:15:56Z</dcterms:created>
  <dcterms:modified xsi:type="dcterms:W3CDTF">2026-06-15T10:18:02Z</dcterms:modified>
</cp:coreProperties>
</file>